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2" r:id="rId2"/>
  </p:sldIdLst>
  <p:sldSz cx="7559675" cy="1069181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774BD37-8360-449A-8250-694456E7724C}" v="1" dt="2022-02-21T07:05:58.6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97" autoAdjust="0"/>
    <p:restoredTop sz="91673" autoAdjust="0"/>
  </p:normalViewPr>
  <p:slideViewPr>
    <p:cSldViewPr snapToGrid="0">
      <p:cViewPr>
        <p:scale>
          <a:sx n="88" d="100"/>
          <a:sy n="88" d="100"/>
        </p:scale>
        <p:origin x="1416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白石 朋敬" userId="695353ff0023d024" providerId="LiveId" clId="{F774BD37-8360-449A-8250-694456E7724C}"/>
    <pc:docChg chg="modSld">
      <pc:chgData name="白石 朋敬" userId="695353ff0023d024" providerId="LiveId" clId="{F774BD37-8360-449A-8250-694456E7724C}" dt="2022-02-21T07:09:37.123" v="92" actId="1036"/>
      <pc:docMkLst>
        <pc:docMk/>
      </pc:docMkLst>
      <pc:sldChg chg="addSp modSp mod modAnim">
        <pc:chgData name="白石 朋敬" userId="695353ff0023d024" providerId="LiveId" clId="{F774BD37-8360-449A-8250-694456E7724C}" dt="2022-02-21T07:09:37.123" v="92" actId="1036"/>
        <pc:sldMkLst>
          <pc:docMk/>
          <pc:sldMk cId="1494219784" sldId="262"/>
        </pc:sldMkLst>
        <pc:spChg chg="mod">
          <ac:chgData name="白石 朋敬" userId="695353ff0023d024" providerId="LiveId" clId="{F774BD37-8360-449A-8250-694456E7724C}" dt="2022-02-21T07:09:31.881" v="86" actId="1035"/>
          <ac:spMkLst>
            <pc:docMk/>
            <pc:sldMk cId="1494219784" sldId="262"/>
            <ac:spMk id="13" creationId="{50AA223F-D563-4FB3-858D-19A44F780314}"/>
          </ac:spMkLst>
        </pc:spChg>
        <pc:spChg chg="mod">
          <ac:chgData name="白石 朋敬" userId="695353ff0023d024" providerId="LiveId" clId="{F774BD37-8360-449A-8250-694456E7724C}" dt="2022-02-21T07:09:31.881" v="86" actId="1035"/>
          <ac:spMkLst>
            <pc:docMk/>
            <pc:sldMk cId="1494219784" sldId="262"/>
            <ac:spMk id="14" creationId="{10CD1DA0-2DCA-4C7E-993C-4BD2A7CFC868}"/>
          </ac:spMkLst>
        </pc:spChg>
        <pc:spChg chg="mod">
          <ac:chgData name="白石 朋敬" userId="695353ff0023d024" providerId="LiveId" clId="{F774BD37-8360-449A-8250-694456E7724C}" dt="2022-02-21T07:09:31.881" v="86" actId="1035"/>
          <ac:spMkLst>
            <pc:docMk/>
            <pc:sldMk cId="1494219784" sldId="262"/>
            <ac:spMk id="15" creationId="{AF6B3FE4-5368-4A93-9B21-6B4E16BF578B}"/>
          </ac:spMkLst>
        </pc:spChg>
        <pc:spChg chg="add mod">
          <ac:chgData name="白石 朋敬" userId="695353ff0023d024" providerId="LiveId" clId="{F774BD37-8360-449A-8250-694456E7724C}" dt="2022-02-21T07:08:45.076" v="34" actId="1076"/>
          <ac:spMkLst>
            <pc:docMk/>
            <pc:sldMk cId="1494219784" sldId="262"/>
            <ac:spMk id="28" creationId="{0C50723B-4F44-49EE-A79E-82C5C1D4A06D}"/>
          </ac:spMkLst>
        </pc:spChg>
        <pc:spChg chg="add mod">
          <ac:chgData name="白石 朋敬" userId="695353ff0023d024" providerId="LiveId" clId="{F774BD37-8360-449A-8250-694456E7724C}" dt="2022-02-21T07:08:45.076" v="34" actId="1076"/>
          <ac:spMkLst>
            <pc:docMk/>
            <pc:sldMk cId="1494219784" sldId="262"/>
            <ac:spMk id="29" creationId="{57F22481-557D-4B9A-BD3F-531BDC55F6B7}"/>
          </ac:spMkLst>
        </pc:spChg>
        <pc:spChg chg="add mod">
          <ac:chgData name="白石 朋敬" userId="695353ff0023d024" providerId="LiveId" clId="{F774BD37-8360-449A-8250-694456E7724C}" dt="2022-02-21T07:08:45.076" v="34" actId="1076"/>
          <ac:spMkLst>
            <pc:docMk/>
            <pc:sldMk cId="1494219784" sldId="262"/>
            <ac:spMk id="30" creationId="{45E944A1-9E20-411D-BB38-8C6E6E6F32EA}"/>
          </ac:spMkLst>
        </pc:spChg>
        <pc:spChg chg="add mod">
          <ac:chgData name="白石 朋敬" userId="695353ff0023d024" providerId="LiveId" clId="{F774BD37-8360-449A-8250-694456E7724C}" dt="2022-02-21T07:09:37.123" v="92" actId="1036"/>
          <ac:spMkLst>
            <pc:docMk/>
            <pc:sldMk cId="1494219784" sldId="262"/>
            <ac:spMk id="31" creationId="{F4E2836D-0354-4A01-99B7-80C1EA8E48EA}"/>
          </ac:spMkLst>
        </pc:spChg>
        <pc:spChg chg="add mod">
          <ac:chgData name="白石 朋敬" userId="695353ff0023d024" providerId="LiveId" clId="{F774BD37-8360-449A-8250-694456E7724C}" dt="2022-02-21T07:09:37.123" v="92" actId="1036"/>
          <ac:spMkLst>
            <pc:docMk/>
            <pc:sldMk cId="1494219784" sldId="262"/>
            <ac:spMk id="32" creationId="{AA75CE58-E3F5-4C7F-825D-A7B6771D9C46}"/>
          </ac:spMkLst>
        </pc:spChg>
        <pc:spChg chg="add mod">
          <ac:chgData name="白石 朋敬" userId="695353ff0023d024" providerId="LiveId" clId="{F774BD37-8360-449A-8250-694456E7724C}" dt="2022-02-21T07:09:37.123" v="92" actId="1036"/>
          <ac:spMkLst>
            <pc:docMk/>
            <pc:sldMk cId="1494219784" sldId="262"/>
            <ac:spMk id="33" creationId="{61CB4218-6AD1-404C-8B96-72EEC58CCBF1}"/>
          </ac:spMkLst>
        </pc:spChg>
        <pc:picChg chg="mod">
          <ac:chgData name="白石 朋敬" userId="695353ff0023d024" providerId="LiveId" clId="{F774BD37-8360-449A-8250-694456E7724C}" dt="2022-02-21T07:06:17.861" v="3" actId="552"/>
          <ac:picMkLst>
            <pc:docMk/>
            <pc:sldMk cId="1494219784" sldId="262"/>
            <ac:picMk id="11" creationId="{B52D4BE5-4DE7-4D53-9E94-0A9DD500B43C}"/>
          </ac:picMkLst>
        </pc:picChg>
        <pc:picChg chg="mod">
          <ac:chgData name="白石 朋敬" userId="695353ff0023d024" providerId="LiveId" clId="{F774BD37-8360-449A-8250-694456E7724C}" dt="2022-02-21T07:06:24.553" v="4" actId="552"/>
          <ac:picMkLst>
            <pc:docMk/>
            <pc:sldMk cId="1494219784" sldId="262"/>
            <ac:picMk id="12" creationId="{77F34E9F-1C1A-4241-B35B-47B13B8E662E}"/>
          </ac:picMkLst>
        </pc:picChg>
        <pc:picChg chg="add mod">
          <ac:chgData name="白石 朋敬" userId="695353ff0023d024" providerId="LiveId" clId="{F774BD37-8360-449A-8250-694456E7724C}" dt="2022-02-21T07:08:08.331" v="28" actId="1036"/>
          <ac:picMkLst>
            <pc:docMk/>
            <pc:sldMk cId="1494219784" sldId="262"/>
            <ac:picMk id="16" creationId="{7CE70D41-5722-411B-B2DC-4D8697B9A78B}"/>
          </ac:picMkLst>
        </pc:picChg>
        <pc:picChg chg="add mod">
          <ac:chgData name="白石 朋敬" userId="695353ff0023d024" providerId="LiveId" clId="{F774BD37-8360-449A-8250-694456E7724C}" dt="2022-02-21T07:08:08.331" v="28" actId="1036"/>
          <ac:picMkLst>
            <pc:docMk/>
            <pc:sldMk cId="1494219784" sldId="262"/>
            <ac:picMk id="17" creationId="{C7CC80BB-7E07-4544-8E6F-008A58DC5468}"/>
          </ac:picMkLst>
        </pc:picChg>
        <pc:picChg chg="add mod">
          <ac:chgData name="白石 朋敬" userId="695353ff0023d024" providerId="LiveId" clId="{F774BD37-8360-449A-8250-694456E7724C}" dt="2022-02-21T07:08:08.331" v="28" actId="1036"/>
          <ac:picMkLst>
            <pc:docMk/>
            <pc:sldMk cId="1494219784" sldId="262"/>
            <ac:picMk id="18" creationId="{F5219BA2-8DEA-479E-B448-76E0ED80EC37}"/>
          </ac:picMkLst>
        </pc:picChg>
        <pc:cxnChg chg="add mod">
          <ac:chgData name="白石 朋敬" userId="695353ff0023d024" providerId="LiveId" clId="{F774BD37-8360-449A-8250-694456E7724C}" dt="2022-02-21T07:08:08.331" v="28" actId="1036"/>
          <ac:cxnSpMkLst>
            <pc:docMk/>
            <pc:sldMk cId="1494219784" sldId="262"/>
            <ac:cxnSpMk id="19" creationId="{78769A29-40DA-4C97-9976-1E0F203D212B}"/>
          </ac:cxnSpMkLst>
        </pc:cxnChg>
        <pc:cxnChg chg="add mod">
          <ac:chgData name="白石 朋敬" userId="695353ff0023d024" providerId="LiveId" clId="{F774BD37-8360-449A-8250-694456E7724C}" dt="2022-02-21T07:08:08.331" v="28" actId="1036"/>
          <ac:cxnSpMkLst>
            <pc:docMk/>
            <pc:sldMk cId="1494219784" sldId="262"/>
            <ac:cxnSpMk id="20" creationId="{0BF87B26-474C-416B-B415-33B17B17CCBA}"/>
          </ac:cxnSpMkLst>
        </pc:cxnChg>
        <pc:cxnChg chg="add mod">
          <ac:chgData name="白石 朋敬" userId="695353ff0023d024" providerId="LiveId" clId="{F774BD37-8360-449A-8250-694456E7724C}" dt="2022-02-21T07:08:08.331" v="28" actId="1036"/>
          <ac:cxnSpMkLst>
            <pc:docMk/>
            <pc:sldMk cId="1494219784" sldId="262"/>
            <ac:cxnSpMk id="24" creationId="{82A437D4-926D-4A1A-A332-20806EFCB249}"/>
          </ac:cxnSpMkLst>
        </pc:cxnChg>
        <pc:cxnChg chg="add mod">
          <ac:chgData name="白石 朋敬" userId="695353ff0023d024" providerId="LiveId" clId="{F774BD37-8360-449A-8250-694456E7724C}" dt="2022-02-21T07:08:35.885" v="32" actId="1076"/>
          <ac:cxnSpMkLst>
            <pc:docMk/>
            <pc:sldMk cId="1494219784" sldId="262"/>
            <ac:cxnSpMk id="25" creationId="{18FB97C2-931E-4037-835F-595E9198D033}"/>
          </ac:cxnSpMkLst>
        </pc:cxnChg>
        <pc:cxnChg chg="add mod">
          <ac:chgData name="白石 朋敬" userId="695353ff0023d024" providerId="LiveId" clId="{F774BD37-8360-449A-8250-694456E7724C}" dt="2022-02-21T07:08:35.885" v="32" actId="1076"/>
          <ac:cxnSpMkLst>
            <pc:docMk/>
            <pc:sldMk cId="1494219784" sldId="262"/>
            <ac:cxnSpMk id="26" creationId="{51952DA1-0F05-4D8A-B559-58B998591F90}"/>
          </ac:cxnSpMkLst>
        </pc:cxnChg>
        <pc:cxnChg chg="add mod">
          <ac:chgData name="白石 朋敬" userId="695353ff0023d024" providerId="LiveId" clId="{F774BD37-8360-449A-8250-694456E7724C}" dt="2022-02-21T07:08:35.885" v="32" actId="1076"/>
          <ac:cxnSpMkLst>
            <pc:docMk/>
            <pc:sldMk cId="1494219784" sldId="262"/>
            <ac:cxnSpMk id="27" creationId="{E4773F58-E7DA-477B-9306-E6278B3560D4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AE575D-E15D-4052-BD8B-C23BEC40A4D5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41425"/>
            <a:ext cx="23653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16BA58-59A8-4056-9436-DD2825D4C3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200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1pPr>
    <a:lvl2pPr marL="399639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2pPr>
    <a:lvl3pPr marL="799277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3pPr>
    <a:lvl4pPr marL="1198916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4pPr>
    <a:lvl5pPr marL="1598554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5pPr>
    <a:lvl6pPr marL="1998193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6pPr>
    <a:lvl7pPr marL="2397831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7pPr>
    <a:lvl8pPr marL="2797470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8pPr>
    <a:lvl9pPr marL="3197108" algn="l" defTabSz="799277" rtl="0" eaLnBrk="1" latinLnBrk="0" hangingPunct="1">
      <a:defRPr kumimoji="1" sz="104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16BA58-59A8-4056-9436-DD2825D4C3D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6809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06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916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076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618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93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942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1222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135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378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3261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349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913C7-3163-48C7-A329-789A4E5C9D7B}" type="datetimeFigureOut">
              <a:rPr kumimoji="1" lang="ja-JP" altLang="en-US" smtClean="0"/>
              <a:t>2022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E761F-6828-4A9D-A9D5-FD2542F45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176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13" Type="http://schemas.openxmlformats.org/officeDocument/2006/relationships/image" Target="../media/image4.png"/><Relationship Id="rId3" Type="http://schemas.microsoft.com/office/2007/relationships/media" Target="../media/media2.avi"/><Relationship Id="rId7" Type="http://schemas.microsoft.com/office/2007/relationships/media" Target="../media/media6.avi"/><Relationship Id="rId12" Type="http://schemas.openxmlformats.org/officeDocument/2006/relationships/image" Target="../media/image3.png"/><Relationship Id="rId2" Type="http://schemas.microsoft.com/office/2007/relationships/media" Target="../media/media1.avi"/><Relationship Id="rId1" Type="http://schemas.openxmlformats.org/officeDocument/2006/relationships/video" Target="NULL" TargetMode="External"/><Relationship Id="rId6" Type="http://schemas.microsoft.com/office/2007/relationships/media" Target="../media/media5.avi"/><Relationship Id="rId11" Type="http://schemas.openxmlformats.org/officeDocument/2006/relationships/image" Target="../media/image2.png"/><Relationship Id="rId5" Type="http://schemas.microsoft.com/office/2007/relationships/media" Target="../media/media4.avi"/><Relationship Id="rId15" Type="http://schemas.openxmlformats.org/officeDocument/2006/relationships/image" Target="../media/image6.png"/><Relationship Id="rId10" Type="http://schemas.openxmlformats.org/officeDocument/2006/relationships/image" Target="../media/image1.png"/><Relationship Id="rId4" Type="http://schemas.microsoft.com/office/2007/relationships/media" Target="../media/media3.avi"/><Relationship Id="rId9" Type="http://schemas.openxmlformats.org/officeDocument/2006/relationships/notesSlide" Target="../notesSlides/notesSlide1.xml"/><Relationship Id="rId1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Composite">
            <a:hlinkClick r:id="" action="ppaction://media"/>
            <a:extLst>
              <a:ext uri="{FF2B5EF4-FFF2-40B4-BE49-F238E27FC236}">
                <a16:creationId xmlns:a16="http://schemas.microsoft.com/office/drawing/2014/main" id="{5C81799B-9114-41AB-AF0A-AD8033975BB0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14705"/>
                </p14:media>
              </p:ext>
            </p:extLst>
          </p:nvPr>
        </p:nvPicPr>
        <p:blipFill rotWithShape="1">
          <a:blip r:embed="rId10">
            <a:lum bright="20000" contrast="20000"/>
          </a:blip>
          <a:srcRect l="47820" t="31262" r="38608" b="55052"/>
          <a:stretch>
            <a:fillRect/>
          </a:stretch>
        </p:blipFill>
        <p:spPr>
          <a:xfrm>
            <a:off x="739131" y="671360"/>
            <a:ext cx="1844379" cy="1859725"/>
          </a:xfrm>
          <a:prstGeom prst="rect">
            <a:avLst/>
          </a:prstGeom>
        </p:spPr>
      </p:pic>
      <p:pic>
        <p:nvPicPr>
          <p:cNvPr id="11" name="green">
            <a:hlinkClick r:id="" action="ppaction://media"/>
            <a:extLst>
              <a:ext uri="{FF2B5EF4-FFF2-40B4-BE49-F238E27FC236}">
                <a16:creationId xmlns:a16="http://schemas.microsoft.com/office/drawing/2014/main" id="{B52D4BE5-4DE7-4D53-9E94-0A9DD500B43C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3">
                  <p14:trim st="14705"/>
                </p14:media>
              </p:ext>
            </p:extLst>
          </p:nvPr>
        </p:nvPicPr>
        <p:blipFill rotWithShape="1">
          <a:blip r:embed="rId11">
            <a:lum bright="20000" contrast="20000"/>
          </a:blip>
          <a:srcRect l="47593" t="31340" r="38834" b="54974"/>
          <a:stretch>
            <a:fillRect/>
          </a:stretch>
        </p:blipFill>
        <p:spPr>
          <a:xfrm>
            <a:off x="3089357" y="671358"/>
            <a:ext cx="1844380" cy="1859727"/>
          </a:xfrm>
          <a:prstGeom prst="rect">
            <a:avLst/>
          </a:prstGeom>
        </p:spPr>
      </p:pic>
      <p:pic>
        <p:nvPicPr>
          <p:cNvPr id="12" name="red">
            <a:hlinkClick r:id="" action="ppaction://media"/>
            <a:extLst>
              <a:ext uri="{FF2B5EF4-FFF2-40B4-BE49-F238E27FC236}">
                <a16:creationId xmlns:a16="http://schemas.microsoft.com/office/drawing/2014/main" id="{77F34E9F-1C1A-4241-B35B-47B13B8E662E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4">
                  <p14:trim st="14705"/>
                </p14:media>
              </p:ext>
            </p:extLst>
          </p:nvPr>
        </p:nvPicPr>
        <p:blipFill rotWithShape="1">
          <a:blip r:embed="rId12">
            <a:lum bright="20000" contrast="20000"/>
          </a:blip>
          <a:srcRect l="47857" t="31353" r="38658" b="55049"/>
          <a:stretch>
            <a:fillRect/>
          </a:stretch>
        </p:blipFill>
        <p:spPr>
          <a:xfrm>
            <a:off x="5446226" y="671356"/>
            <a:ext cx="1844380" cy="1859727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0AA223F-D563-4FB3-858D-19A44F780314}"/>
              </a:ext>
            </a:extLst>
          </p:cNvPr>
          <p:cNvSpPr txBox="1"/>
          <p:nvPr/>
        </p:nvSpPr>
        <p:spPr>
          <a:xfrm>
            <a:off x="739131" y="359483"/>
            <a:ext cx="1023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Video. 5 </a:t>
            </a:r>
            <a:endParaRPr kumimoji="1" lang="ja-JP" altLang="en-US" b="1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0CD1DA0-2DCA-4C7E-993C-4BD2A7CFC868}"/>
              </a:ext>
            </a:extLst>
          </p:cNvPr>
          <p:cNvSpPr txBox="1"/>
          <p:nvPr/>
        </p:nvSpPr>
        <p:spPr>
          <a:xfrm>
            <a:off x="3057805" y="359483"/>
            <a:ext cx="100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Video. 6 </a:t>
            </a:r>
            <a:endParaRPr kumimoji="1" lang="ja-JP" altLang="en-US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F6B3FE4-5368-4A93-9B21-6B4E16BF578B}"/>
              </a:ext>
            </a:extLst>
          </p:cNvPr>
          <p:cNvSpPr txBox="1"/>
          <p:nvPr/>
        </p:nvSpPr>
        <p:spPr>
          <a:xfrm>
            <a:off x="5423695" y="359483"/>
            <a:ext cx="100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Video. 7 </a:t>
            </a:r>
            <a:endParaRPr kumimoji="1" lang="ja-JP" altLang="en-US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5EFF654-16FC-48FF-B71B-918B568C1A46}"/>
              </a:ext>
            </a:extLst>
          </p:cNvPr>
          <p:cNvSpPr txBox="1"/>
          <p:nvPr/>
        </p:nvSpPr>
        <p:spPr>
          <a:xfrm rot="16200000">
            <a:off x="-454536" y="1195762"/>
            <a:ext cx="17425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0000"/>
                </a:solidFill>
              </a:rPr>
              <a:t>mCherry-Rab10</a:t>
            </a:r>
            <a:r>
              <a:rPr kumimoji="1" lang="ja-JP" altLang="en-US" dirty="0"/>
              <a:t> </a:t>
            </a:r>
            <a:endParaRPr kumimoji="1" lang="en-US" altLang="ja-JP" dirty="0"/>
          </a:p>
          <a:p>
            <a:pPr algn="ctr"/>
            <a:r>
              <a:rPr kumimoji="1" lang="en-US" altLang="ja-JP" dirty="0">
                <a:solidFill>
                  <a:schemeClr val="accent6">
                    <a:lumMod val="75000"/>
                  </a:schemeClr>
                </a:solidFill>
              </a:rPr>
              <a:t>EGFP-Rab9</a:t>
            </a:r>
            <a:endParaRPr kumimoji="1" lang="ja-JP" altLang="en-US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F45FDF0-B405-45D4-824E-EC68D9795FD1}"/>
              </a:ext>
            </a:extLst>
          </p:cNvPr>
          <p:cNvSpPr txBox="1"/>
          <p:nvPr/>
        </p:nvSpPr>
        <p:spPr>
          <a:xfrm rot="16200000">
            <a:off x="4406422" y="1334261"/>
            <a:ext cx="1710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mCherry-Rab10</a:t>
            </a:r>
            <a:r>
              <a:rPr kumimoji="1" lang="ja-JP" altLang="en-US" dirty="0"/>
              <a:t> </a:t>
            </a:r>
            <a:endParaRPr kumimoji="1" lang="en-US" altLang="ja-JP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992161A-6085-42B1-96BA-63B838E7F6D7}"/>
              </a:ext>
            </a:extLst>
          </p:cNvPr>
          <p:cNvSpPr txBox="1"/>
          <p:nvPr/>
        </p:nvSpPr>
        <p:spPr>
          <a:xfrm rot="16200000">
            <a:off x="2299942" y="1334261"/>
            <a:ext cx="1209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EGFP-Rab9</a:t>
            </a:r>
            <a:endParaRPr kumimoji="1" lang="ja-JP" altLang="en-US" dirty="0"/>
          </a:p>
        </p:txBody>
      </p:sp>
      <p:pic>
        <p:nvPicPr>
          <p:cNvPr id="16" name="Composite">
            <a:hlinkClick r:id="" action="ppaction://media"/>
            <a:extLst>
              <a:ext uri="{FF2B5EF4-FFF2-40B4-BE49-F238E27FC236}">
                <a16:creationId xmlns:a16="http://schemas.microsoft.com/office/drawing/2014/main" id="{7CE70D41-5722-411B-B2DC-4D8697B9A78B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5">
                  <p14:trim st="12503" end="7607"/>
                </p14:media>
              </p:ext>
            </p:extLst>
          </p:nvPr>
        </p:nvPicPr>
        <p:blipFill rotWithShape="1">
          <a:blip r:embed="rId13"/>
          <a:srcRect l="26038" t="32773" r="52196" b="45244"/>
          <a:stretch/>
        </p:blipFill>
        <p:spPr>
          <a:xfrm>
            <a:off x="739131" y="2986737"/>
            <a:ext cx="1841329" cy="1859725"/>
          </a:xfrm>
          <a:prstGeom prst="rect">
            <a:avLst/>
          </a:prstGeom>
        </p:spPr>
      </p:pic>
      <p:pic>
        <p:nvPicPr>
          <p:cNvPr id="17" name="green">
            <a:hlinkClick r:id="" action="ppaction://media"/>
            <a:extLst>
              <a:ext uri="{FF2B5EF4-FFF2-40B4-BE49-F238E27FC236}">
                <a16:creationId xmlns:a16="http://schemas.microsoft.com/office/drawing/2014/main" id="{C7CC80BB-7E07-4544-8E6F-008A58DC5468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6">
                  <p14:trim st="12503" end="7607"/>
                </p14:media>
              </p:ext>
            </p:extLst>
          </p:nvPr>
        </p:nvPicPr>
        <p:blipFill rotWithShape="1">
          <a:blip r:embed="rId14"/>
          <a:srcRect l="26003" t="32984" r="52159" b="45032"/>
          <a:stretch/>
        </p:blipFill>
        <p:spPr>
          <a:xfrm>
            <a:off x="3089357" y="2986736"/>
            <a:ext cx="1847426" cy="1859725"/>
          </a:xfrm>
          <a:prstGeom prst="rect">
            <a:avLst/>
          </a:prstGeom>
        </p:spPr>
      </p:pic>
      <p:pic>
        <p:nvPicPr>
          <p:cNvPr id="18" name="red">
            <a:hlinkClick r:id="" action="ppaction://media"/>
            <a:extLst>
              <a:ext uri="{FF2B5EF4-FFF2-40B4-BE49-F238E27FC236}">
                <a16:creationId xmlns:a16="http://schemas.microsoft.com/office/drawing/2014/main" id="{F5219BA2-8DEA-479E-B448-76E0ED80EC37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7">
                  <p14:trim st="12503" end="7607"/>
                </p14:media>
              </p:ext>
            </p:extLst>
          </p:nvPr>
        </p:nvPicPr>
        <p:blipFill rotWithShape="1">
          <a:blip r:embed="rId15"/>
          <a:srcRect l="26133" t="33158" r="52064" b="44859"/>
          <a:stretch/>
        </p:blipFill>
        <p:spPr>
          <a:xfrm>
            <a:off x="5446226" y="2986736"/>
            <a:ext cx="1844378" cy="1859725"/>
          </a:xfrm>
          <a:prstGeom prst="rect">
            <a:avLst/>
          </a:prstGeom>
        </p:spPr>
      </p:pic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78769A29-40DA-4C97-9976-1E0F203D212B}"/>
              </a:ext>
            </a:extLst>
          </p:cNvPr>
          <p:cNvCxnSpPr>
            <a:cxnSpLocks/>
          </p:cNvCxnSpPr>
          <p:nvPr/>
        </p:nvCxnSpPr>
        <p:spPr>
          <a:xfrm>
            <a:off x="3661603" y="3694134"/>
            <a:ext cx="251502" cy="226709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0BF87B26-474C-416B-B415-33B17B17CCBA}"/>
              </a:ext>
            </a:extLst>
          </p:cNvPr>
          <p:cNvCxnSpPr>
            <a:cxnSpLocks/>
          </p:cNvCxnSpPr>
          <p:nvPr/>
        </p:nvCxnSpPr>
        <p:spPr>
          <a:xfrm>
            <a:off x="5994810" y="3694135"/>
            <a:ext cx="274618" cy="226708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82A437D4-926D-4A1A-A332-20806EFCB249}"/>
              </a:ext>
            </a:extLst>
          </p:cNvPr>
          <p:cNvCxnSpPr>
            <a:cxnSpLocks/>
          </p:cNvCxnSpPr>
          <p:nvPr/>
        </p:nvCxnSpPr>
        <p:spPr>
          <a:xfrm>
            <a:off x="1304360" y="3694135"/>
            <a:ext cx="259644" cy="226708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18FB97C2-931E-4037-835F-595E9198D033}"/>
              </a:ext>
            </a:extLst>
          </p:cNvPr>
          <p:cNvCxnSpPr>
            <a:cxnSpLocks/>
          </p:cNvCxnSpPr>
          <p:nvPr/>
        </p:nvCxnSpPr>
        <p:spPr>
          <a:xfrm flipH="1">
            <a:off x="4119411" y="1183637"/>
            <a:ext cx="251502" cy="226709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51952DA1-0F05-4D8A-B559-58B998591F90}"/>
              </a:ext>
            </a:extLst>
          </p:cNvPr>
          <p:cNvCxnSpPr>
            <a:cxnSpLocks/>
          </p:cNvCxnSpPr>
          <p:nvPr/>
        </p:nvCxnSpPr>
        <p:spPr>
          <a:xfrm flipH="1">
            <a:off x="6452618" y="1183638"/>
            <a:ext cx="274618" cy="226708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E4773F58-E7DA-477B-9306-E6278B3560D4}"/>
              </a:ext>
            </a:extLst>
          </p:cNvPr>
          <p:cNvCxnSpPr>
            <a:cxnSpLocks/>
          </p:cNvCxnSpPr>
          <p:nvPr/>
        </p:nvCxnSpPr>
        <p:spPr>
          <a:xfrm flipH="1">
            <a:off x="1762168" y="1183638"/>
            <a:ext cx="259644" cy="226708"/>
          </a:xfrm>
          <a:prstGeom prst="straightConnector1">
            <a:avLst/>
          </a:prstGeom>
          <a:ln w="571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C50723B-4F44-49EE-A79E-82C5C1D4A06D}"/>
              </a:ext>
            </a:extLst>
          </p:cNvPr>
          <p:cNvSpPr txBox="1"/>
          <p:nvPr/>
        </p:nvSpPr>
        <p:spPr>
          <a:xfrm rot="16200000">
            <a:off x="-458115" y="3518707"/>
            <a:ext cx="17425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0000"/>
                </a:solidFill>
              </a:rPr>
              <a:t>mCherry-Rab10</a:t>
            </a:r>
            <a:r>
              <a:rPr kumimoji="1" lang="ja-JP" altLang="en-US" dirty="0"/>
              <a:t> </a:t>
            </a:r>
            <a:endParaRPr kumimoji="1" lang="en-US" altLang="ja-JP" dirty="0"/>
          </a:p>
          <a:p>
            <a:pPr algn="ctr"/>
            <a:r>
              <a:rPr kumimoji="1" lang="en-US" altLang="ja-JP" dirty="0">
                <a:solidFill>
                  <a:schemeClr val="accent6">
                    <a:lumMod val="75000"/>
                  </a:schemeClr>
                </a:solidFill>
              </a:rPr>
              <a:t>EGFP-Rab9</a:t>
            </a:r>
            <a:endParaRPr kumimoji="1" lang="ja-JP" altLang="en-US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7F22481-557D-4B9A-BD3F-531BDC55F6B7}"/>
              </a:ext>
            </a:extLst>
          </p:cNvPr>
          <p:cNvSpPr txBox="1"/>
          <p:nvPr/>
        </p:nvSpPr>
        <p:spPr>
          <a:xfrm rot="16200000">
            <a:off x="4402843" y="3657206"/>
            <a:ext cx="1710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mCherry-Rab10</a:t>
            </a:r>
            <a:r>
              <a:rPr kumimoji="1" lang="ja-JP" altLang="en-US" dirty="0"/>
              <a:t> </a:t>
            </a:r>
            <a:endParaRPr kumimoji="1" lang="en-US" altLang="ja-JP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5E944A1-9E20-411D-BB38-8C6E6E6F32EA}"/>
              </a:ext>
            </a:extLst>
          </p:cNvPr>
          <p:cNvSpPr txBox="1"/>
          <p:nvPr/>
        </p:nvSpPr>
        <p:spPr>
          <a:xfrm rot="16200000">
            <a:off x="2296363" y="3657206"/>
            <a:ext cx="1209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EGFP-Rab9</a:t>
            </a:r>
            <a:endParaRPr kumimoji="1" lang="ja-JP" altLang="en-US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4E2836D-0354-4A01-99B7-80C1EA8E48EA}"/>
              </a:ext>
            </a:extLst>
          </p:cNvPr>
          <p:cNvSpPr txBox="1"/>
          <p:nvPr/>
        </p:nvSpPr>
        <p:spPr>
          <a:xfrm>
            <a:off x="682667" y="2661015"/>
            <a:ext cx="1023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Video. 8 </a:t>
            </a:r>
            <a:endParaRPr kumimoji="1" lang="ja-JP" altLang="en-US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A75CE58-E3F5-4C7F-825D-A7B6771D9C46}"/>
              </a:ext>
            </a:extLst>
          </p:cNvPr>
          <p:cNvSpPr txBox="1"/>
          <p:nvPr/>
        </p:nvSpPr>
        <p:spPr>
          <a:xfrm>
            <a:off x="3001341" y="2661015"/>
            <a:ext cx="100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Video. 9 </a:t>
            </a:r>
            <a:endParaRPr kumimoji="1" lang="ja-JP" altLang="en-US" b="1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1CB4218-6AD1-404C-8B96-72EEC58CCBF1}"/>
              </a:ext>
            </a:extLst>
          </p:cNvPr>
          <p:cNvSpPr txBox="1"/>
          <p:nvPr/>
        </p:nvSpPr>
        <p:spPr>
          <a:xfrm>
            <a:off x="5367231" y="2661015"/>
            <a:ext cx="1360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Video. 10 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4942197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9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5795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5795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9890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9890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6" dur="9890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27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8" fill="hold">
                      <p:stCondLst>
                        <p:cond delay="0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1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seq concurrent="1" nextAc="seek">
              <p:cTn id="37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8" fill="hold">
                      <p:stCondLst>
                        <p:cond delay="0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1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42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43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video>
              <p:cMediaNode vol="80000">
                <p:cTn id="44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45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6" fill="hold">
                      <p:stCondLst>
                        <p:cond delay="0"/>
                      </p:stCondLst>
                      <p:childTnLst>
                        <p:par>
                          <p:cTn id="47" fill="hold">
                            <p:stCondLst>
                              <p:cond delay="0"/>
                            </p:stCondLst>
                            <p:childTnLst>
                              <p:par>
                                <p:cTn id="4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9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seq concurrent="1" nextAc="seek">
              <p:cTn id="50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1" fill="hold">
                      <p:stCondLst>
                        <p:cond delay="0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4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seq concurrent="1" nextAc="seek">
              <p:cTn id="55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6" fill="hold">
                      <p:stCondLst>
                        <p:cond delay="0"/>
                      </p:stCondLst>
                      <p:childTnLst>
                        <p:par>
                          <p:cTn id="57" fill="hold">
                            <p:stCondLst>
                              <p:cond delay="0"/>
                            </p:stCondLst>
                            <p:childTnLst>
                              <p:par>
                                <p:cTn id="5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9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60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video>
              <p:cMediaNode vol="80000">
                <p:cTn id="61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video>
              <p:cMediaNode vol="80000">
                <p:cTn id="62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16</TotalTime>
  <Words>27</Words>
  <Application>Microsoft Office PowerPoint</Application>
  <PresentationFormat>ユーザー設定</PresentationFormat>
  <Paragraphs>15</Paragraphs>
  <Slides>1</Slides>
  <Notes>1</Notes>
  <HiddenSlides>0</HiddenSlides>
  <MMClips>6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白石 朋敬</dc:creator>
  <cp:lastModifiedBy>白石 朋敬</cp:lastModifiedBy>
  <cp:revision>57</cp:revision>
  <cp:lastPrinted>2021-11-22T01:09:48Z</cp:lastPrinted>
  <dcterms:created xsi:type="dcterms:W3CDTF">2021-10-29T06:35:49Z</dcterms:created>
  <dcterms:modified xsi:type="dcterms:W3CDTF">2022-02-21T07:09:41Z</dcterms:modified>
</cp:coreProperties>
</file>